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75" autoAdjust="0"/>
    <p:restoredTop sz="94660"/>
  </p:normalViewPr>
  <p:slideViewPr>
    <p:cSldViewPr snapToGrid="0">
      <p:cViewPr varScale="1">
        <p:scale>
          <a:sx n="94" d="100"/>
          <a:sy n="94" d="100"/>
        </p:scale>
        <p:origin x="36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849D8D-8135-A2D8-8843-F223B61073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C996DF7-8E58-F608-2B12-A728B024A5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B476A1-C681-D74E-34CE-1BB1E5D42E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AAC69-E7B6-470E-88A4-EF214F90444C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73B49B-EA03-DF35-877E-319F57FBD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CD154D-628D-DE77-9B06-C091FEDBAE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10519-7874-4E03-953A-FE146D925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767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5B6F04-10EF-0C4C-ABCE-8380BAC0E5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EDD648-F290-A0DA-67E1-7412E751E9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74DD3A-EB13-A596-2877-2697C728A3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AAC69-E7B6-470E-88A4-EF214F90444C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AE24B2-3A2F-CBA9-BA02-9D1F1F48F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49BB99-4533-334B-35F1-1F50DA207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10519-7874-4E03-953A-FE146D925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544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2FA29CA-14F5-E6A3-814F-C6D04459F6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9FC01A-90F1-9693-97AC-7A989BDB0B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542DFD-F035-5BCA-034F-3A856EC0B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AAC69-E7B6-470E-88A4-EF214F90444C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F97420-FF78-8B45-BAE7-1092FB8ACD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E5C630-70B9-69C8-800B-8A68EF0977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10519-7874-4E03-953A-FE146D925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7455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C0BA1C-FCB6-6551-8C80-0D637F316B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5DBC0C-4438-2312-EF8A-DF1D06F99C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A99324-31B1-1980-C8BA-BA4C23C59A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AAC69-E7B6-470E-88A4-EF214F90444C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1FE04F-6E0C-5469-DFBB-E7E0414074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75530D-E4C6-8542-2A4E-9478786764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10519-7874-4E03-953A-FE146D925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008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965D5E-DA81-CAA7-6161-7FD17F68AC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C5E4B6-3FD9-7200-E43D-6F9828ACC1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820739-A9EB-4106-A189-D4B8158EC8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AAC69-E7B6-470E-88A4-EF214F90444C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1C2919-18CD-F785-A083-202F362D53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335885-0F88-2E9A-B322-A9594864C4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10519-7874-4E03-953A-FE146D925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9753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2B4935-2DD2-6956-949F-54D842BCDE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F9A694-1A61-75C3-D260-BDFB6E0DB5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5D3272-FF94-104F-5D32-ECAB3CFAB2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B20FAF-9A75-55AD-78A2-C5AD4154FB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AAC69-E7B6-470E-88A4-EF214F90444C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7F2050-0C9A-C4D3-5FDD-29214B354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EBF34F-720E-3C87-E305-CF46B53C1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10519-7874-4E03-953A-FE146D925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1577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4575EE-EDFB-83BD-5F88-CF9B897806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878B20-2783-E4D1-8724-71DBCBD941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2465BE-1678-E9CD-C211-4255E14A9D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5DE0CFC-226E-5FC0-BF40-4FC2CE6CDFE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A446465-24D8-938B-CE5A-F195EE6809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79B687A-8678-74B6-97D5-26D2E8A5C1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AAC69-E7B6-470E-88A4-EF214F90444C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603B6AA-3893-925A-CF3E-59E0A408C8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D4F81D0-65D4-FEA7-1414-37A8FF064F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10519-7874-4E03-953A-FE146D925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07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542BEF-E979-5AFD-0961-3F81BFB959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084EF2-6D70-A6A8-F2B9-CEF13EF25E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AAC69-E7B6-470E-88A4-EF214F90444C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D98061-AB97-3C09-A52C-9801EF00B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2F323F-7674-4966-1E7F-A857AE321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10519-7874-4E03-953A-FE146D925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424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CA790E7-76D3-F7E6-1E48-95CBF81AD0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AAC69-E7B6-470E-88A4-EF214F90444C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0FEF731-1558-37A7-07A0-E28A081A6F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8422328-6E3B-35E4-8D9A-2F60E45F7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10519-7874-4E03-953A-FE146D925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486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D7D461-8900-249A-C607-95E573D633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F6B306-77F5-8E48-7957-162C66301CB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4847C8-3A6B-6FA4-2D4A-2F7DC03B3F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46E4B7-83C3-8A0F-C3F9-15C29EC019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AAC69-E7B6-470E-88A4-EF214F90444C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A61CB3-BA45-DB2E-97D3-DF68623EC2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BFCBE9-3E41-E494-7081-D19C1AFF99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10519-7874-4E03-953A-FE146D925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9577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BE8203-A4A2-8607-91BF-6A71242B90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BF66F6-0D14-DC0B-4588-5B4BBBA157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B8B8BA5-35D9-A2E3-7AB8-EE27F26269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B4DFC5-E8E2-09A1-AA4B-E9FA0C0BF6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AAC69-E7B6-470E-88A4-EF214F90444C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CD5A3F-360E-2119-3325-E49FE69B23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E885D0-547B-FCA1-6B11-414E157D12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10519-7874-4E03-953A-FE146D925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737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5F91A1B-7688-742E-F200-FC78C23C44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C1D6C0-28FA-9ED9-7FBE-C761305CC3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6B0D67-1B9B-D70E-9885-FB3EC60C77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AAAC69-E7B6-470E-88A4-EF214F90444C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6C3769-0217-9483-3107-B5FB0EB8B3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844A18-8540-2B18-1714-BF4D0246AF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610519-7874-4E03-953A-FE146D925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373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0DCEDDBB-5BFD-4D23-8657-7EF008609EBC}"/>
              </a:ext>
            </a:extLst>
          </p:cNvPr>
          <p:cNvSpPr txBox="1"/>
          <p:nvPr/>
        </p:nvSpPr>
        <p:spPr>
          <a:xfrm>
            <a:off x="82062" y="40585"/>
            <a:ext cx="2005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S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19BF8DD-6004-4A1F-819D-F2E033D2A1ED}"/>
              </a:ext>
            </a:extLst>
          </p:cNvPr>
          <p:cNvSpPr txBox="1"/>
          <p:nvPr/>
        </p:nvSpPr>
        <p:spPr>
          <a:xfrm>
            <a:off x="398583" y="1015556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FD8D245E-16CF-4C24-A219-8E7209EA0310}"/>
              </a:ext>
            </a:extLst>
          </p:cNvPr>
          <p:cNvSpPr/>
          <p:nvPr/>
        </p:nvSpPr>
        <p:spPr>
          <a:xfrm>
            <a:off x="3972373" y="3125341"/>
            <a:ext cx="2307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D21C52C-46CF-4042-B2C5-25B96153E41A}"/>
              </a:ext>
            </a:extLst>
          </p:cNvPr>
          <p:cNvSpPr txBox="1"/>
          <p:nvPr/>
        </p:nvSpPr>
        <p:spPr>
          <a:xfrm>
            <a:off x="386954" y="302569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63F1E83-152B-46C8-9798-1584BED6A77B}"/>
              </a:ext>
            </a:extLst>
          </p:cNvPr>
          <p:cNvSpPr txBox="1"/>
          <p:nvPr/>
        </p:nvSpPr>
        <p:spPr>
          <a:xfrm>
            <a:off x="2353298" y="1916833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PER</a:t>
            </a:r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12AAAC44-E8A3-473A-B198-7F830ED680A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lum bright="-2000" contrast="19000"/>
          </a:blip>
          <a:srcRect t="16495" b="5875"/>
          <a:stretch/>
        </p:blipFill>
        <p:spPr>
          <a:xfrm>
            <a:off x="848509" y="3880473"/>
            <a:ext cx="1463040" cy="301752"/>
          </a:xfrm>
          <a:prstGeom prst="rect">
            <a:avLst/>
          </a:prstGeom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E4ECF21F-A65B-44DC-9989-387C7DAF3965}"/>
              </a:ext>
            </a:extLst>
          </p:cNvPr>
          <p:cNvSpPr txBox="1"/>
          <p:nvPr/>
        </p:nvSpPr>
        <p:spPr>
          <a:xfrm>
            <a:off x="961009" y="3454844"/>
            <a:ext cx="253947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       +        -      +      500nM LNS8801</a:t>
            </a:r>
          </a:p>
          <a:p>
            <a:pPr marL="171450" indent="-171450">
              <a:buFontTx/>
              <a:buChar char="-"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   -        +      +      5000nM G-36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0718103-C95F-4BC0-8D28-FB0146CF0C3E}"/>
              </a:ext>
            </a:extLst>
          </p:cNvPr>
          <p:cNvSpPr txBox="1"/>
          <p:nvPr/>
        </p:nvSpPr>
        <p:spPr>
          <a:xfrm>
            <a:off x="2313331" y="3895553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-CREB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3B6A4D7D-695A-4CC4-8EEB-890ACCD619FE}"/>
              </a:ext>
            </a:extLst>
          </p:cNvPr>
          <p:cNvSpPr txBox="1"/>
          <p:nvPr/>
        </p:nvSpPr>
        <p:spPr>
          <a:xfrm>
            <a:off x="2288166" y="4224557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RE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396384C-C231-47A2-8AA0-92270755D20D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lum bright="-20000" contrast="40000"/>
          </a:blip>
          <a:stretch>
            <a:fillRect/>
          </a:stretch>
        </p:blipFill>
        <p:spPr>
          <a:xfrm>
            <a:off x="848509" y="4243285"/>
            <a:ext cx="1463040" cy="30175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9076AFF-BB8C-42F5-8954-4EDF7D8894D2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870846" y="2245735"/>
            <a:ext cx="1463040" cy="27432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55EA5B1-9EC4-49A5-AA6C-4FA179E3CBB6}"/>
              </a:ext>
            </a:extLst>
          </p:cNvPr>
          <p:cNvSpPr txBox="1"/>
          <p:nvPr/>
        </p:nvSpPr>
        <p:spPr>
          <a:xfrm>
            <a:off x="2348809" y="2221067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F4AB866-D358-4593-BCA2-A0E23B1911CE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lum bright="27000" contrast="29000"/>
          </a:blip>
          <a:stretch>
            <a:fillRect/>
          </a:stretch>
        </p:blipFill>
        <p:spPr>
          <a:xfrm flipH="1">
            <a:off x="916566" y="1919512"/>
            <a:ext cx="1371600" cy="274320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08DB1F10-625E-44D4-8D7B-6DAC677EF9D1}"/>
              </a:ext>
            </a:extLst>
          </p:cNvPr>
          <p:cNvSpPr/>
          <p:nvPr/>
        </p:nvSpPr>
        <p:spPr>
          <a:xfrm>
            <a:off x="3972373" y="942947"/>
            <a:ext cx="30489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0B0BD27-396E-4B7B-B38F-B4A5401B917E}"/>
              </a:ext>
            </a:extLst>
          </p:cNvPr>
          <p:cNvSpPr txBox="1"/>
          <p:nvPr/>
        </p:nvSpPr>
        <p:spPr>
          <a:xfrm>
            <a:off x="4588155" y="3455277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39BB7E2-AF2A-452D-B3AA-D88447CC53C2}"/>
              </a:ext>
            </a:extLst>
          </p:cNvPr>
          <p:cNvSpPr txBox="1"/>
          <p:nvPr/>
        </p:nvSpPr>
        <p:spPr>
          <a:xfrm>
            <a:off x="6212834" y="3421292"/>
            <a:ext cx="11384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-36 (5000nM)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C0DDB9D-8A06-41B9-9B41-DD37E3FBF00E}"/>
              </a:ext>
            </a:extLst>
          </p:cNvPr>
          <p:cNvSpPr txBox="1"/>
          <p:nvPr/>
        </p:nvSpPr>
        <p:spPr>
          <a:xfrm>
            <a:off x="7817677" y="3443352"/>
            <a:ext cx="13372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NS8801 (500nM)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C430EF6-652B-492E-BAC1-62A81E90B0C9}"/>
              </a:ext>
            </a:extLst>
          </p:cNvPr>
          <p:cNvSpPr txBox="1"/>
          <p:nvPr/>
        </p:nvSpPr>
        <p:spPr>
          <a:xfrm>
            <a:off x="9524145" y="3438361"/>
            <a:ext cx="12458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-36 + LNS8801</a:t>
            </a:r>
          </a:p>
        </p:txBody>
      </p:sp>
      <p:grpSp>
        <p:nvGrpSpPr>
          <p:cNvPr id="63" name="Group 62">
            <a:extLst>
              <a:ext uri="{FF2B5EF4-FFF2-40B4-BE49-F238E27FC236}">
                <a16:creationId xmlns:a16="http://schemas.microsoft.com/office/drawing/2014/main" id="{3D463797-94B6-4B1C-9FA2-81D6C9199BF9}"/>
              </a:ext>
            </a:extLst>
          </p:cNvPr>
          <p:cNvGrpSpPr/>
          <p:nvPr/>
        </p:nvGrpSpPr>
        <p:grpSpPr>
          <a:xfrm>
            <a:off x="4316084" y="1406201"/>
            <a:ext cx="1554480" cy="1280160"/>
            <a:chOff x="703523" y="936578"/>
            <a:chExt cx="1554480" cy="1371600"/>
          </a:xfrm>
        </p:grpSpPr>
        <p:pic>
          <p:nvPicPr>
            <p:cNvPr id="70" name="Picture 5">
              <a:extLst>
                <a:ext uri="{FF2B5EF4-FFF2-40B4-BE49-F238E27FC236}">
                  <a16:creationId xmlns:a16="http://schemas.microsoft.com/office/drawing/2014/main" id="{D0E311C6-8DC7-4B5F-8C31-3D905D96B823}"/>
                </a:ext>
              </a:extLst>
            </p:cNvPr>
            <p:cNvPicPr>
              <a:picLocks/>
            </p:cNvPicPr>
            <p:nvPr/>
          </p:nvPicPr>
          <p:blipFill rotWithShape="1">
            <a:blip r:embed="rId6"/>
            <a:srcRect l="4999" t="11525" r="5048" b="4157"/>
            <a:stretch/>
          </p:blipFill>
          <p:spPr>
            <a:xfrm>
              <a:off x="703523" y="936578"/>
              <a:ext cx="1554480" cy="1371600"/>
            </a:xfrm>
            <a:prstGeom prst="rect">
              <a:avLst/>
            </a:prstGeom>
          </p:spPr>
        </p:pic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0C6F1993-CFD8-4364-82B4-48EE6219909B}"/>
                </a:ext>
              </a:extLst>
            </p:cNvPr>
            <p:cNvSpPr txBox="1"/>
            <p:nvPr/>
          </p:nvSpPr>
          <p:spPr>
            <a:xfrm>
              <a:off x="1583453" y="1031769"/>
              <a:ext cx="554960" cy="42868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PM2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.9%</a:t>
              </a:r>
            </a:p>
          </p:txBody>
        </p:sp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F10D480D-5901-468A-9113-312B21B291CC}"/>
              </a:ext>
            </a:extLst>
          </p:cNvPr>
          <p:cNvGrpSpPr/>
          <p:nvPr/>
        </p:nvGrpSpPr>
        <p:grpSpPr>
          <a:xfrm>
            <a:off x="5971213" y="1461817"/>
            <a:ext cx="1463040" cy="1208062"/>
            <a:chOff x="3280266" y="1014877"/>
            <a:chExt cx="1554480" cy="1371600"/>
          </a:xfrm>
        </p:grpSpPr>
        <p:pic>
          <p:nvPicPr>
            <p:cNvPr id="73" name="Picture 5">
              <a:extLst>
                <a:ext uri="{FF2B5EF4-FFF2-40B4-BE49-F238E27FC236}">
                  <a16:creationId xmlns:a16="http://schemas.microsoft.com/office/drawing/2014/main" id="{1C7368A8-E3C6-4201-8D20-398E504B8E40}"/>
                </a:ext>
              </a:extLst>
            </p:cNvPr>
            <p:cNvPicPr>
              <a:picLocks/>
            </p:cNvPicPr>
            <p:nvPr/>
          </p:nvPicPr>
          <p:blipFill rotWithShape="1">
            <a:blip r:embed="rId7"/>
            <a:srcRect l="10048" t="15161" r="3322" b="2923"/>
            <a:stretch/>
          </p:blipFill>
          <p:spPr>
            <a:xfrm>
              <a:off x="3280266" y="1014877"/>
              <a:ext cx="1554480" cy="1371600"/>
            </a:xfrm>
            <a:prstGeom prst="rect">
              <a:avLst/>
            </a:prstGeom>
          </p:spPr>
        </p:pic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229BD7C9-1C20-4C63-BE59-2BB12392D742}"/>
                </a:ext>
              </a:extLst>
            </p:cNvPr>
            <p:cNvSpPr txBox="1"/>
            <p:nvPr/>
          </p:nvSpPr>
          <p:spPr>
            <a:xfrm>
              <a:off x="4073668" y="1024284"/>
              <a:ext cx="589645" cy="45427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PM2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.9%</a:t>
              </a:r>
            </a:p>
          </p:txBody>
        </p: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D9638F67-A12A-40E4-87AC-C0153CA466BC}"/>
              </a:ext>
            </a:extLst>
          </p:cNvPr>
          <p:cNvGrpSpPr/>
          <p:nvPr/>
        </p:nvGrpSpPr>
        <p:grpSpPr>
          <a:xfrm>
            <a:off x="7666441" y="1382069"/>
            <a:ext cx="1463040" cy="1279714"/>
            <a:chOff x="5879607" y="1014878"/>
            <a:chExt cx="1645920" cy="1371600"/>
          </a:xfrm>
        </p:grpSpPr>
        <p:pic>
          <p:nvPicPr>
            <p:cNvPr id="76" name="Picture 5">
              <a:extLst>
                <a:ext uri="{FF2B5EF4-FFF2-40B4-BE49-F238E27FC236}">
                  <a16:creationId xmlns:a16="http://schemas.microsoft.com/office/drawing/2014/main" id="{8BE88902-2770-4F50-ABE3-6671578B5CD5}"/>
                </a:ext>
              </a:extLst>
            </p:cNvPr>
            <p:cNvPicPr>
              <a:picLocks/>
            </p:cNvPicPr>
            <p:nvPr/>
          </p:nvPicPr>
          <p:blipFill rotWithShape="1">
            <a:blip r:embed="rId8"/>
            <a:srcRect l="10047" t="15316" r="2042" b="3740"/>
            <a:stretch/>
          </p:blipFill>
          <p:spPr>
            <a:xfrm>
              <a:off x="5879607" y="1014878"/>
              <a:ext cx="1645920" cy="1371600"/>
            </a:xfrm>
            <a:prstGeom prst="rect">
              <a:avLst/>
            </a:prstGeom>
          </p:spPr>
        </p:pic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AEE33305-3DDE-447E-8C93-1BB40FCC1F33}"/>
                </a:ext>
              </a:extLst>
            </p:cNvPr>
            <p:cNvSpPr txBox="1"/>
            <p:nvPr/>
          </p:nvSpPr>
          <p:spPr>
            <a:xfrm>
              <a:off x="6713206" y="1089786"/>
              <a:ext cx="624330" cy="42883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PM2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.0%</a:t>
              </a:r>
            </a:p>
          </p:txBody>
        </p:sp>
      </p:grpSp>
      <p:grpSp>
        <p:nvGrpSpPr>
          <p:cNvPr id="78" name="Group 77">
            <a:extLst>
              <a:ext uri="{FF2B5EF4-FFF2-40B4-BE49-F238E27FC236}">
                <a16:creationId xmlns:a16="http://schemas.microsoft.com/office/drawing/2014/main" id="{A73B3490-CB5C-47DE-B614-38A2FAA29FD5}"/>
              </a:ext>
            </a:extLst>
          </p:cNvPr>
          <p:cNvGrpSpPr/>
          <p:nvPr/>
        </p:nvGrpSpPr>
        <p:grpSpPr>
          <a:xfrm>
            <a:off x="9282582" y="1370792"/>
            <a:ext cx="1463040" cy="1279596"/>
            <a:chOff x="8360227" y="723050"/>
            <a:chExt cx="1554480" cy="1371600"/>
          </a:xfrm>
        </p:grpSpPr>
        <p:pic>
          <p:nvPicPr>
            <p:cNvPr id="79" name="Picture 5">
              <a:extLst>
                <a:ext uri="{FF2B5EF4-FFF2-40B4-BE49-F238E27FC236}">
                  <a16:creationId xmlns:a16="http://schemas.microsoft.com/office/drawing/2014/main" id="{6C7BBAFD-FE1E-4720-AB9D-D3DC4141CEC7}"/>
                </a:ext>
              </a:extLst>
            </p:cNvPr>
            <p:cNvPicPr>
              <a:picLocks/>
            </p:cNvPicPr>
            <p:nvPr/>
          </p:nvPicPr>
          <p:blipFill rotWithShape="1">
            <a:blip r:embed="rId9"/>
            <a:srcRect l="9159" t="15316" r="3884" b="3740"/>
            <a:stretch/>
          </p:blipFill>
          <p:spPr>
            <a:xfrm>
              <a:off x="8360227" y="723050"/>
              <a:ext cx="1554480" cy="1371600"/>
            </a:xfrm>
            <a:prstGeom prst="rect">
              <a:avLst/>
            </a:prstGeom>
          </p:spPr>
        </p:pic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2ACFEAEC-E428-48B6-B91F-5402215D75A6}"/>
                </a:ext>
              </a:extLst>
            </p:cNvPr>
            <p:cNvSpPr txBox="1"/>
            <p:nvPr/>
          </p:nvSpPr>
          <p:spPr>
            <a:xfrm>
              <a:off x="9175125" y="808608"/>
              <a:ext cx="589645" cy="42887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PM2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6.8%</a:t>
              </a:r>
            </a:p>
          </p:txBody>
        </p:sp>
      </p:grpSp>
      <p:sp>
        <p:nvSpPr>
          <p:cNvPr id="81" name="TextBox 80">
            <a:extLst>
              <a:ext uri="{FF2B5EF4-FFF2-40B4-BE49-F238E27FC236}">
                <a16:creationId xmlns:a16="http://schemas.microsoft.com/office/drawing/2014/main" id="{7F2D2D5A-7FB0-44B9-B935-9F2E5688F62E}"/>
              </a:ext>
            </a:extLst>
          </p:cNvPr>
          <p:cNvSpPr txBox="1"/>
          <p:nvPr/>
        </p:nvSpPr>
        <p:spPr>
          <a:xfrm>
            <a:off x="4639207" y="1219780"/>
            <a:ext cx="6792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9EAEC94-671F-4CC4-86E1-EBA31AD858CD}"/>
              </a:ext>
            </a:extLst>
          </p:cNvPr>
          <p:cNvSpPr txBox="1"/>
          <p:nvPr/>
        </p:nvSpPr>
        <p:spPr>
          <a:xfrm>
            <a:off x="5721530" y="895170"/>
            <a:ext cx="6832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u="sng" dirty="0" err="1">
                <a:latin typeface="Arial" panose="020B0604020202020204" pitchFamily="34" charset="0"/>
                <a:cs typeface="Arial" panose="020B0604020202020204" pitchFamily="34" charset="0"/>
              </a:rPr>
              <a:t>siCTR</a:t>
            </a:r>
            <a:endParaRPr lang="en-US" sz="14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A34F0C3-F494-4A5A-9944-2F0D8324D4D8}"/>
              </a:ext>
            </a:extLst>
          </p:cNvPr>
          <p:cNvSpPr txBox="1"/>
          <p:nvPr/>
        </p:nvSpPr>
        <p:spPr>
          <a:xfrm>
            <a:off x="6263188" y="1207123"/>
            <a:ext cx="8832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NS8801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FEBC3C37-603B-46D9-B657-34C5CBDC8192}"/>
              </a:ext>
            </a:extLst>
          </p:cNvPr>
          <p:cNvSpPr txBox="1"/>
          <p:nvPr/>
        </p:nvSpPr>
        <p:spPr>
          <a:xfrm>
            <a:off x="8678792" y="895884"/>
            <a:ext cx="9829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u="sng" dirty="0" err="1">
                <a:latin typeface="Arial" panose="020B0604020202020204" pitchFamily="34" charset="0"/>
                <a:cs typeface="Arial" panose="020B0604020202020204" pitchFamily="34" charset="0"/>
              </a:rPr>
              <a:t>siGPER</a:t>
            </a:r>
            <a:r>
              <a:rPr lang="en-US" sz="1400" u="sng" dirty="0">
                <a:latin typeface="Arial" panose="020B0604020202020204" pitchFamily="34" charset="0"/>
                <a:cs typeface="Arial" panose="020B0604020202020204" pitchFamily="34" charset="0"/>
              </a:rPr>
              <a:t>-a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D8222A82-66A0-4300-909F-CC174C2B4953}"/>
              </a:ext>
            </a:extLst>
          </p:cNvPr>
          <p:cNvSpPr txBox="1"/>
          <p:nvPr/>
        </p:nvSpPr>
        <p:spPr>
          <a:xfrm>
            <a:off x="7880197" y="1192147"/>
            <a:ext cx="6792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F06EF941-4868-4799-B166-45DBBF9F7FF1}"/>
              </a:ext>
            </a:extLst>
          </p:cNvPr>
          <p:cNvSpPr txBox="1"/>
          <p:nvPr/>
        </p:nvSpPr>
        <p:spPr>
          <a:xfrm>
            <a:off x="9486252" y="1183625"/>
            <a:ext cx="8425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NS8801</a:t>
            </a:r>
          </a:p>
        </p:txBody>
      </p:sp>
      <p:grpSp>
        <p:nvGrpSpPr>
          <p:cNvPr id="87" name="Group 86">
            <a:extLst>
              <a:ext uri="{FF2B5EF4-FFF2-40B4-BE49-F238E27FC236}">
                <a16:creationId xmlns:a16="http://schemas.microsoft.com/office/drawing/2014/main" id="{C40F0589-208E-4161-AEE4-44C5F1957FAD}"/>
              </a:ext>
            </a:extLst>
          </p:cNvPr>
          <p:cNvGrpSpPr/>
          <p:nvPr/>
        </p:nvGrpSpPr>
        <p:grpSpPr>
          <a:xfrm>
            <a:off x="4308768" y="3757233"/>
            <a:ext cx="1554480" cy="1280160"/>
            <a:chOff x="137892" y="5461633"/>
            <a:chExt cx="1554480" cy="1280160"/>
          </a:xfrm>
        </p:grpSpPr>
        <p:pic>
          <p:nvPicPr>
            <p:cNvPr id="88" name="Picture 5">
              <a:extLst>
                <a:ext uri="{FF2B5EF4-FFF2-40B4-BE49-F238E27FC236}">
                  <a16:creationId xmlns:a16="http://schemas.microsoft.com/office/drawing/2014/main" id="{C2EEC837-6F6F-4D23-B6D7-8D912B334A55}"/>
                </a:ext>
              </a:extLst>
            </p:cNvPr>
            <p:cNvPicPr>
              <a:picLocks/>
            </p:cNvPicPr>
            <p:nvPr/>
          </p:nvPicPr>
          <p:blipFill rotWithShape="1">
            <a:blip r:embed="rId10"/>
            <a:srcRect l="2500" t="13526" r="2809" b="3849"/>
            <a:stretch/>
          </p:blipFill>
          <p:spPr>
            <a:xfrm>
              <a:off x="137892" y="5461633"/>
              <a:ext cx="1554480" cy="1280160"/>
            </a:xfrm>
            <a:prstGeom prst="rect">
              <a:avLst/>
            </a:prstGeom>
          </p:spPr>
        </p:pic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7C093BAC-DE80-4053-A3A1-A0DF08BC2A46}"/>
                </a:ext>
              </a:extLst>
            </p:cNvPr>
            <p:cNvSpPr txBox="1"/>
            <p:nvPr/>
          </p:nvSpPr>
          <p:spPr>
            <a:xfrm>
              <a:off x="1029477" y="5533372"/>
              <a:ext cx="554960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PM2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.7%</a:t>
              </a:r>
            </a:p>
          </p:txBody>
        </p:sp>
      </p:grpSp>
      <p:grpSp>
        <p:nvGrpSpPr>
          <p:cNvPr id="90" name="Group 89">
            <a:extLst>
              <a:ext uri="{FF2B5EF4-FFF2-40B4-BE49-F238E27FC236}">
                <a16:creationId xmlns:a16="http://schemas.microsoft.com/office/drawing/2014/main" id="{4539C1CE-9E8C-487A-BB79-AD585DA306D0}"/>
              </a:ext>
            </a:extLst>
          </p:cNvPr>
          <p:cNvGrpSpPr/>
          <p:nvPr/>
        </p:nvGrpSpPr>
        <p:grpSpPr>
          <a:xfrm>
            <a:off x="5950347" y="3757233"/>
            <a:ext cx="1463040" cy="1280160"/>
            <a:chOff x="2087739" y="5377002"/>
            <a:chExt cx="1463040" cy="1280160"/>
          </a:xfrm>
        </p:grpSpPr>
        <p:pic>
          <p:nvPicPr>
            <p:cNvPr id="91" name="Picture 5">
              <a:extLst>
                <a:ext uri="{FF2B5EF4-FFF2-40B4-BE49-F238E27FC236}">
                  <a16:creationId xmlns:a16="http://schemas.microsoft.com/office/drawing/2014/main" id="{E33C0B19-0FBA-4674-AD26-B663B9E3A531}"/>
                </a:ext>
              </a:extLst>
            </p:cNvPr>
            <p:cNvPicPr>
              <a:picLocks/>
            </p:cNvPicPr>
            <p:nvPr/>
          </p:nvPicPr>
          <p:blipFill rotWithShape="1">
            <a:blip r:embed="rId11"/>
            <a:srcRect l="7693" t="15487" r="4011" b="3626"/>
            <a:stretch/>
          </p:blipFill>
          <p:spPr>
            <a:xfrm>
              <a:off x="2087739" y="5377002"/>
              <a:ext cx="1463040" cy="1280160"/>
            </a:xfrm>
            <a:prstGeom prst="rect">
              <a:avLst/>
            </a:prstGeom>
          </p:spPr>
        </p:pic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BA9E766D-F137-4851-9F5F-9DD76D94015D}"/>
                </a:ext>
              </a:extLst>
            </p:cNvPr>
            <p:cNvSpPr txBox="1"/>
            <p:nvPr/>
          </p:nvSpPr>
          <p:spPr>
            <a:xfrm>
              <a:off x="2892622" y="5481544"/>
              <a:ext cx="554960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PM2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.3%</a:t>
              </a:r>
            </a:p>
          </p:txBody>
        </p:sp>
      </p:grpSp>
      <p:grpSp>
        <p:nvGrpSpPr>
          <p:cNvPr id="93" name="Group 92">
            <a:extLst>
              <a:ext uri="{FF2B5EF4-FFF2-40B4-BE49-F238E27FC236}">
                <a16:creationId xmlns:a16="http://schemas.microsoft.com/office/drawing/2014/main" id="{4A895EAF-0167-4403-88D4-E947EE4A0087}"/>
              </a:ext>
            </a:extLst>
          </p:cNvPr>
          <p:cNvGrpSpPr/>
          <p:nvPr/>
        </p:nvGrpSpPr>
        <p:grpSpPr>
          <a:xfrm>
            <a:off x="7649118" y="3757233"/>
            <a:ext cx="1463040" cy="1280160"/>
            <a:chOff x="3408331" y="5459699"/>
            <a:chExt cx="1463040" cy="1280160"/>
          </a:xfrm>
        </p:grpSpPr>
        <p:pic>
          <p:nvPicPr>
            <p:cNvPr id="94" name="Picture 5">
              <a:extLst>
                <a:ext uri="{FF2B5EF4-FFF2-40B4-BE49-F238E27FC236}">
                  <a16:creationId xmlns:a16="http://schemas.microsoft.com/office/drawing/2014/main" id="{496497C7-C20D-4C14-9C25-7D17CB5D9F61}"/>
                </a:ext>
              </a:extLst>
            </p:cNvPr>
            <p:cNvPicPr>
              <a:picLocks/>
            </p:cNvPicPr>
            <p:nvPr/>
          </p:nvPicPr>
          <p:blipFill rotWithShape="1">
            <a:blip r:embed="rId12"/>
            <a:srcRect l="7792" t="15962" r="3400" b="3222"/>
            <a:stretch/>
          </p:blipFill>
          <p:spPr>
            <a:xfrm>
              <a:off x="3408331" y="5459699"/>
              <a:ext cx="1463040" cy="1280160"/>
            </a:xfrm>
            <a:prstGeom prst="rect">
              <a:avLst/>
            </a:prstGeom>
          </p:spPr>
        </p:pic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582594B1-2762-454E-AA20-D81952225738}"/>
                </a:ext>
              </a:extLst>
            </p:cNvPr>
            <p:cNvSpPr txBox="1"/>
            <p:nvPr/>
          </p:nvSpPr>
          <p:spPr>
            <a:xfrm>
              <a:off x="4259769" y="5564241"/>
              <a:ext cx="554960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PM2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.0%</a:t>
              </a:r>
            </a:p>
          </p:txBody>
        </p:sp>
      </p:grpSp>
      <p:grpSp>
        <p:nvGrpSpPr>
          <p:cNvPr id="96" name="Group 95">
            <a:extLst>
              <a:ext uri="{FF2B5EF4-FFF2-40B4-BE49-F238E27FC236}">
                <a16:creationId xmlns:a16="http://schemas.microsoft.com/office/drawing/2014/main" id="{22859E07-FA1E-4CDE-99A0-41F430DE9FE8}"/>
              </a:ext>
            </a:extLst>
          </p:cNvPr>
          <p:cNvGrpSpPr/>
          <p:nvPr/>
        </p:nvGrpSpPr>
        <p:grpSpPr>
          <a:xfrm>
            <a:off x="9347889" y="3757233"/>
            <a:ext cx="1463040" cy="1280160"/>
            <a:chOff x="4992956" y="5486400"/>
            <a:chExt cx="1463040" cy="1280160"/>
          </a:xfrm>
        </p:grpSpPr>
        <p:pic>
          <p:nvPicPr>
            <p:cNvPr id="97" name="Picture 5">
              <a:extLst>
                <a:ext uri="{FF2B5EF4-FFF2-40B4-BE49-F238E27FC236}">
                  <a16:creationId xmlns:a16="http://schemas.microsoft.com/office/drawing/2014/main" id="{F5BE4350-19EE-440E-9F32-8A941CBCD671}"/>
                </a:ext>
              </a:extLst>
            </p:cNvPr>
            <p:cNvPicPr>
              <a:picLocks/>
            </p:cNvPicPr>
            <p:nvPr/>
          </p:nvPicPr>
          <p:blipFill rotWithShape="1">
            <a:blip r:embed="rId13"/>
            <a:srcRect l="8198" t="14334" r="3506" b="3675"/>
            <a:stretch/>
          </p:blipFill>
          <p:spPr>
            <a:xfrm>
              <a:off x="4992956" y="5486400"/>
              <a:ext cx="1463040" cy="1280160"/>
            </a:xfrm>
            <a:prstGeom prst="rect">
              <a:avLst/>
            </a:prstGeom>
          </p:spPr>
        </p:pic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0C36101C-AD01-45F6-96E2-76B41D4BE462}"/>
                </a:ext>
              </a:extLst>
            </p:cNvPr>
            <p:cNvSpPr txBox="1"/>
            <p:nvPr/>
          </p:nvSpPr>
          <p:spPr>
            <a:xfrm>
              <a:off x="5862213" y="5575427"/>
              <a:ext cx="554960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PM2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9.5%</a:t>
              </a:r>
            </a:p>
          </p:txBody>
        </p: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61C42565-8FCF-4404-8D8D-59B805F1ED2F}"/>
              </a:ext>
            </a:extLst>
          </p:cNvPr>
          <p:cNvSpPr txBox="1"/>
          <p:nvPr/>
        </p:nvSpPr>
        <p:spPr>
          <a:xfrm>
            <a:off x="2301608" y="4571817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1700C046-E2CB-4B0F-AB0D-CDD9043494B2}"/>
              </a:ext>
            </a:extLst>
          </p:cNvPr>
          <p:cNvPicPr preferRelativeResize="0">
            <a:picLocks/>
          </p:cNvPicPr>
          <p:nvPr/>
        </p:nvPicPr>
        <p:blipFill>
          <a:blip r:embed="rId14">
            <a:lum bright="-20000" contrast="40000"/>
          </a:blip>
          <a:stretch>
            <a:fillRect/>
          </a:stretch>
        </p:blipFill>
        <p:spPr>
          <a:xfrm>
            <a:off x="848509" y="4591017"/>
            <a:ext cx="1463040" cy="27432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9DF4D7B0-C5A1-490D-83DF-3F254CA0F7EA}"/>
              </a:ext>
            </a:extLst>
          </p:cNvPr>
          <p:cNvSpPr txBox="1"/>
          <p:nvPr/>
        </p:nvSpPr>
        <p:spPr>
          <a:xfrm>
            <a:off x="994507" y="1285816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CT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C3D0A95-3B3E-4EF2-A981-57F6B22EA648}"/>
              </a:ext>
            </a:extLst>
          </p:cNvPr>
          <p:cNvSpPr txBox="1"/>
          <p:nvPr/>
        </p:nvSpPr>
        <p:spPr>
          <a:xfrm>
            <a:off x="1629361" y="1269568"/>
            <a:ext cx="867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 err="1">
                <a:latin typeface="Arial" panose="020B0604020202020204" pitchFamily="34" charset="0"/>
                <a:cs typeface="Arial" panose="020B0604020202020204" pitchFamily="34" charset="0"/>
              </a:rPr>
              <a:t>siGPER</a:t>
            </a:r>
            <a:r>
              <a:rPr lang="en-US" sz="1200" u="sng" dirty="0">
                <a:latin typeface="Arial" panose="020B0604020202020204" pitchFamily="34" charset="0"/>
                <a:cs typeface="Arial" panose="020B0604020202020204" pitchFamily="34" charset="0"/>
              </a:rPr>
              <a:t>-a</a:t>
            </a:r>
            <a:endParaRPr lang="en-US" sz="14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8F7100E-335A-4E43-9682-BBE5938C6CC5}"/>
              </a:ext>
            </a:extLst>
          </p:cNvPr>
          <p:cNvSpPr txBox="1"/>
          <p:nvPr/>
        </p:nvSpPr>
        <p:spPr>
          <a:xfrm flipH="1">
            <a:off x="982897" y="1622796"/>
            <a:ext cx="26661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      +      -      +     500nM LNS880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3DC4DCA-EE08-4B5B-9C1C-78E91BCBFB84}"/>
              </a:ext>
            </a:extLst>
          </p:cNvPr>
          <p:cNvSpPr txBox="1"/>
          <p:nvPr/>
        </p:nvSpPr>
        <p:spPr>
          <a:xfrm>
            <a:off x="701464" y="5391604"/>
            <a:ext cx="1023407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itotic effect of LNS8801 is GPER-independent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mmunoblotting of Omm1.3 cells after transfection with control (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CT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GPER-specific siRNA, showing downregulation of GPER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Omm1.3 cells with silenced GPER were analyzed for mitotic index compared to cells transfected with control siRNA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e GPER antagonist G36 prevented LNS8801-mediated signaling but not the induction of mitosis. Omm1.3 cells were pre-treated with 5000nM G-36 for 4 hours and then treated with 500nM LNS8801 for 1 hour. Immunoblotting was performed to detect expression of p-CREB, CREB and GAPDH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alysis of MPM2-positive mitotic Omm1.3 cells that were pre-treated with G-36 for 4 hours, then treated with or without LNS8801 for 24 hours.</a:t>
            </a:r>
          </a:p>
        </p:txBody>
      </p:sp>
    </p:spTree>
    <p:extLst>
      <p:ext uri="{BB962C8B-B14F-4D97-AF65-F5344CB8AC3E}">
        <p14:creationId xmlns:p14="http://schemas.microsoft.com/office/powerpoint/2010/main" val="1243371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05</Words>
  <Application>Microsoft Office PowerPoint</Application>
  <PresentationFormat>Widescreen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CUI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brosini, Grazia</dc:creator>
  <cp:lastModifiedBy>Ambrosini, Grazia</cp:lastModifiedBy>
  <cp:revision>1</cp:revision>
  <dcterms:created xsi:type="dcterms:W3CDTF">2023-01-19T15:20:53Z</dcterms:created>
  <dcterms:modified xsi:type="dcterms:W3CDTF">2023-01-23T18:44:01Z</dcterms:modified>
</cp:coreProperties>
</file>